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8" r:id="rId3"/>
    <p:sldId id="256" r:id="rId4"/>
    <p:sldId id="259" r:id="rId5"/>
    <p:sldId id="257" r:id="rId6"/>
    <p:sldId id="261" r:id="rId7"/>
    <p:sldId id="262" r:id="rId8"/>
    <p:sldId id="263" r:id="rId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17" d="100"/>
          <a:sy n="117" d="100"/>
        </p:scale>
        <p:origin x="643" y="9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817CD5B-8046-4DBD-A0BD-F89AE31B768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41B7AA55-92DD-4551-9D6A-1DDE354A6EF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329693E-12A3-457B-9434-FECAAEE2BB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7282D-A52B-44BD-84C3-1D41D6ECD2D2}" type="datetimeFigureOut">
              <a:rPr lang="zh-CN" altLang="en-US" smtClean="0"/>
              <a:t>2022/3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1612A5B-B32F-4D90-BBC5-D4AA4F64BF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0E5F6EB-19E8-458A-A243-0618BB1BB8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DB9AF-8A93-4D2E-85ED-3B5B8E384A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60669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4A494FE-A862-4936-BC5C-5BA2E6FECF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4A1D31E-C144-47E2-894D-47681DA3504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034226F-DE7A-4D2B-82A5-9721D94D0B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7282D-A52B-44BD-84C3-1D41D6ECD2D2}" type="datetimeFigureOut">
              <a:rPr lang="zh-CN" altLang="en-US" smtClean="0"/>
              <a:t>2022/3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0B58656-0D5D-4C4C-A7A1-4F9A144D13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7F93235-6811-47C1-BEE2-290728438C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DB9AF-8A93-4D2E-85ED-3B5B8E384A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45390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A226A9CC-4D0E-4B96-850F-84EE2132AA2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830E2EF-0BBA-42B2-A6AB-10D0C68F04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316D7D0-1A27-46F0-8A94-731382E1E2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7282D-A52B-44BD-84C3-1D41D6ECD2D2}" type="datetimeFigureOut">
              <a:rPr lang="zh-CN" altLang="en-US" smtClean="0"/>
              <a:t>2022/3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6EE28C9-237E-4D01-B897-FAD3B51E12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29960DA-9CA4-4646-9BAD-324C378C6F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DB9AF-8A93-4D2E-85ED-3B5B8E384A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95668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A88B094-CE8E-48B0-ACA1-AD9A5F14C0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2F3D3AF-4131-4866-AE46-1423BF1AC5E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C6B153D-E0A6-4FC1-8ABC-B173FECFA1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7282D-A52B-44BD-84C3-1D41D6ECD2D2}" type="datetimeFigureOut">
              <a:rPr lang="zh-CN" altLang="en-US" smtClean="0"/>
              <a:t>2022/3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15F6D59-5529-4085-90A2-B19BDE3E18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4FAB313-7153-40C5-8920-CFEF649203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DB9AF-8A93-4D2E-85ED-3B5B8E384A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62011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DFD0C8C-18BB-4C76-9DD8-38B67250FA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E2AB1A4-6DF9-489B-A338-5C9BBAC963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429F24F-7704-4EC3-A5DE-5272B4427A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7282D-A52B-44BD-84C3-1D41D6ECD2D2}" type="datetimeFigureOut">
              <a:rPr lang="zh-CN" altLang="en-US" smtClean="0"/>
              <a:t>2022/3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C6948A3-E1CD-45F9-B3A7-BD63F623EC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F9AEE5C-B6CE-438D-AD6B-DF9C0F40E4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DB9AF-8A93-4D2E-85ED-3B5B8E384A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16969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51A9A56-4B35-47FC-AE61-2B69791C14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C15622D-790F-405C-AC77-1F3205FFAE6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A18AF12-5398-4CEF-B638-1B5F33EC11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78E3F2D-C1BC-4E51-8EEB-56C89591AC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7282D-A52B-44BD-84C3-1D41D6ECD2D2}" type="datetimeFigureOut">
              <a:rPr lang="zh-CN" altLang="en-US" smtClean="0"/>
              <a:t>2022/3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6873A96-1BD3-4443-9399-E0D09E9116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3797189-5E51-48FC-A923-3518480FEA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DB9AF-8A93-4D2E-85ED-3B5B8E384A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58474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CACFCCE-7778-40DB-906A-F87ACB3376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CB91953-F55D-4480-ACE2-B1D1B44242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CE91D7B-1403-4AD3-90A8-5340C53DB55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192CFD4B-97D7-4AF7-AEEC-CE566E014BC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A880C48D-2B21-43F9-98A8-0D31199EB7F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B031A2E0-18DA-4CBF-9DDE-95B066CA95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7282D-A52B-44BD-84C3-1D41D6ECD2D2}" type="datetimeFigureOut">
              <a:rPr lang="zh-CN" altLang="en-US" smtClean="0"/>
              <a:t>2022/3/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0C891DE8-8882-40F6-9BB4-798A432CCF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42EB00C2-8C91-4A67-8937-2C1795EFB1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DB9AF-8A93-4D2E-85ED-3B5B8E384A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843377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39CF163-7C41-4E3E-8B19-95F5EFB269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07EA1957-2454-4424-A349-5350C32ACC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7282D-A52B-44BD-84C3-1D41D6ECD2D2}" type="datetimeFigureOut">
              <a:rPr lang="zh-CN" altLang="en-US" smtClean="0"/>
              <a:t>2022/3/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A19014F6-FF73-4846-AAC5-C9DF221631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57527D95-5365-491F-B90B-373E610B2A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DB9AF-8A93-4D2E-85ED-3B5B8E384A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24451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C58B855C-B309-4BD0-8BA0-2C34BE1B04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7282D-A52B-44BD-84C3-1D41D6ECD2D2}" type="datetimeFigureOut">
              <a:rPr lang="zh-CN" altLang="en-US" smtClean="0"/>
              <a:t>2022/3/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A927B906-5DF8-4777-9420-C9444766F8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76A7B8A1-9F8F-4C12-B0BD-29CA38ED86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DB9AF-8A93-4D2E-85ED-3B5B8E384A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33935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E621B2E-5FF9-4737-B31B-0E738AB56A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6369068-8E7D-45A0-A140-F4E5601B57D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7463D99-84F4-405F-9F4F-8C9EE5E26CE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78F09C3-0420-42A1-8F06-DC914C5E92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7282D-A52B-44BD-84C3-1D41D6ECD2D2}" type="datetimeFigureOut">
              <a:rPr lang="zh-CN" altLang="en-US" smtClean="0"/>
              <a:t>2022/3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DD5DF99-158E-4F1A-97EE-6E354967F5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28C9407-F20D-4B08-890D-38667C78F3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DB9AF-8A93-4D2E-85ED-3B5B8E384A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84337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A80F0C3-9C6A-4236-A891-9A2B836943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D14B2B1B-9883-4F07-BF37-19872E1CC2E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786C94E-58AF-438B-AAD5-928AA8611B3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7E0DAA9-E6A7-4A4D-996C-A1302E12FC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7282D-A52B-44BD-84C3-1D41D6ECD2D2}" type="datetimeFigureOut">
              <a:rPr lang="zh-CN" altLang="en-US" smtClean="0"/>
              <a:t>2022/3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6477E4B-874E-4ED1-BAEC-B909E67273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3153A21-7C6B-4DA1-B046-568AA8A46E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DB9AF-8A93-4D2E-85ED-3B5B8E384A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89822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E462958A-AA23-48B1-A80A-224B227CB6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45B7DC6-AB88-4FF8-97C9-CBC70431C1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753BB2D-21D2-4FE8-9526-5A5E541A526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17282D-A52B-44BD-84C3-1D41D6ECD2D2}" type="datetimeFigureOut">
              <a:rPr lang="zh-CN" altLang="en-US" smtClean="0"/>
              <a:t>2022/3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A45B98F-8DB7-4C25-8063-37C1F152A12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C9CDF6E-B49B-4A51-AE34-4BD283DEAAE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ADB9AF-8A93-4D2E-85ED-3B5B8E384A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49813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图片 12">
            <a:extLst>
              <a:ext uri="{FF2B5EF4-FFF2-40B4-BE49-F238E27FC236}">
                <a16:creationId xmlns:a16="http://schemas.microsoft.com/office/drawing/2014/main" id="{B8EA41BF-B8F9-4459-91CE-FAB79E0A402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872" y="0"/>
            <a:ext cx="5219700" cy="371475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B8E18A11-4C7A-4686-89EC-3A0FF4301EBF}"/>
              </a:ext>
            </a:extLst>
          </p:cNvPr>
          <p:cNvSpPr txBox="1"/>
          <p:nvPr/>
        </p:nvSpPr>
        <p:spPr>
          <a:xfrm>
            <a:off x="5275572" y="2073414"/>
            <a:ext cx="1402594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/>
              <a:t>IL-6</a:t>
            </a:r>
          </a:p>
          <a:p>
            <a:r>
              <a:rPr lang="en-US" altLang="zh-CN" sz="2400" dirty="0"/>
              <a:t>28KD</a:t>
            </a:r>
            <a:endParaRPr lang="zh-CN" altLang="en-US" sz="2400" dirty="0"/>
          </a:p>
          <a:p>
            <a:endParaRPr lang="zh-CN" altLang="en-US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14805269-5AE6-4BD3-91C2-D05B5515AB9F}"/>
              </a:ext>
            </a:extLst>
          </p:cNvPr>
          <p:cNvSpPr txBox="1"/>
          <p:nvPr/>
        </p:nvSpPr>
        <p:spPr>
          <a:xfrm>
            <a:off x="11049951" y="1404993"/>
            <a:ext cx="1287532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/>
              <a:t>β-actin</a:t>
            </a:r>
          </a:p>
          <a:p>
            <a:r>
              <a:rPr lang="en-US" altLang="zh-CN" sz="2800" dirty="0"/>
              <a:t>42KD</a:t>
            </a: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A9CC87C9-B26E-4B0B-B2AB-935A991F3F26}"/>
              </a:ext>
            </a:extLst>
          </p:cNvPr>
          <p:cNvSpPr txBox="1"/>
          <p:nvPr/>
        </p:nvSpPr>
        <p:spPr>
          <a:xfrm>
            <a:off x="5074920" y="4901090"/>
            <a:ext cx="149271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3600" b="1" dirty="0"/>
              <a:t>Fig.5A</a:t>
            </a:r>
            <a:endParaRPr lang="zh-CN" altLang="en-US" sz="3600" b="1" dirty="0"/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57B2FDCC-5CCB-46B0-8691-2AFA7F7A1EA0}"/>
              </a:ext>
            </a:extLst>
          </p:cNvPr>
          <p:cNvSpPr/>
          <p:nvPr/>
        </p:nvSpPr>
        <p:spPr>
          <a:xfrm>
            <a:off x="2886892" y="2243307"/>
            <a:ext cx="1567543" cy="2315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5" name="图片 14">
            <a:extLst>
              <a:ext uri="{FF2B5EF4-FFF2-40B4-BE49-F238E27FC236}">
                <a16:creationId xmlns:a16="http://schemas.microsoft.com/office/drawing/2014/main" id="{7141DB91-353B-4A09-A3B9-8BADCBAD00E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0" y="240743"/>
            <a:ext cx="4901700" cy="3325183"/>
          </a:xfrm>
          <a:prstGeom prst="rect">
            <a:avLst/>
          </a:prstGeom>
        </p:spPr>
      </p:pic>
      <p:sp>
        <p:nvSpPr>
          <p:cNvPr id="16" name="矩形 15">
            <a:extLst>
              <a:ext uri="{FF2B5EF4-FFF2-40B4-BE49-F238E27FC236}">
                <a16:creationId xmlns:a16="http://schemas.microsoft.com/office/drawing/2014/main" id="{55629212-E8B5-4EF5-A383-DED589448DF3}"/>
              </a:ext>
            </a:extLst>
          </p:cNvPr>
          <p:cNvSpPr/>
          <p:nvPr/>
        </p:nvSpPr>
        <p:spPr>
          <a:xfrm>
            <a:off x="8845732" y="1533558"/>
            <a:ext cx="1567543" cy="2315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40958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83A904ED-FDF8-4E97-84CA-A7850575F243}"/>
              </a:ext>
            </a:extLst>
          </p:cNvPr>
          <p:cNvSpPr txBox="1"/>
          <p:nvPr/>
        </p:nvSpPr>
        <p:spPr>
          <a:xfrm>
            <a:off x="6855312" y="1605143"/>
            <a:ext cx="83067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jak2</a:t>
            </a:r>
          </a:p>
          <a:p>
            <a:r>
              <a:rPr lang="en-US" altLang="zh-CN" dirty="0"/>
              <a:t>125KD</a:t>
            </a:r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DEB636FB-06C2-4C21-A810-58546BA439F0}"/>
              </a:ext>
            </a:extLst>
          </p:cNvPr>
          <p:cNvSpPr txBox="1"/>
          <p:nvPr/>
        </p:nvSpPr>
        <p:spPr>
          <a:xfrm>
            <a:off x="7345680" y="4617068"/>
            <a:ext cx="83067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jak2</a:t>
            </a:r>
          </a:p>
          <a:p>
            <a:r>
              <a:rPr lang="en-US" altLang="zh-CN" dirty="0"/>
              <a:t>150KD</a:t>
            </a:r>
            <a:endParaRPr lang="zh-CN" altLang="en-US" dirty="0"/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id="{D30A4F0B-2CDA-4352-B987-8CCFC8FED3D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7537" y="1535997"/>
            <a:ext cx="6647775" cy="2037743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59FD38CC-0F36-47E6-BF31-7B1F8055C5D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7761" y="3777835"/>
            <a:ext cx="6759210" cy="1657383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208820A1-BCD2-44CB-A333-AC840D8EE360}"/>
              </a:ext>
            </a:extLst>
          </p:cNvPr>
          <p:cNvSpPr txBox="1"/>
          <p:nvPr/>
        </p:nvSpPr>
        <p:spPr>
          <a:xfrm>
            <a:off x="1745356" y="5639313"/>
            <a:ext cx="1470274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3600" b="1" dirty="0"/>
              <a:t>Fig.5C</a:t>
            </a: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8676021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文本框 28">
            <a:extLst>
              <a:ext uri="{FF2B5EF4-FFF2-40B4-BE49-F238E27FC236}">
                <a16:creationId xmlns:a16="http://schemas.microsoft.com/office/drawing/2014/main" id="{11EE065C-0761-4957-9A71-DC77E924612A}"/>
              </a:ext>
            </a:extLst>
          </p:cNvPr>
          <p:cNvSpPr txBox="1"/>
          <p:nvPr/>
        </p:nvSpPr>
        <p:spPr>
          <a:xfrm>
            <a:off x="4679055" y="1418223"/>
            <a:ext cx="91242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stat3</a:t>
            </a:r>
          </a:p>
          <a:p>
            <a:r>
              <a:rPr lang="en-US" altLang="zh-CN" dirty="0"/>
              <a:t>105KD</a:t>
            </a:r>
          </a:p>
          <a:p>
            <a:endParaRPr lang="zh-CN" altLang="en-US" dirty="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057EBBEC-A41D-4272-AB30-5171249CA094}"/>
              </a:ext>
            </a:extLst>
          </p:cNvPr>
          <p:cNvSpPr txBox="1"/>
          <p:nvPr/>
        </p:nvSpPr>
        <p:spPr>
          <a:xfrm>
            <a:off x="4803287" y="3409697"/>
            <a:ext cx="83708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tat3</a:t>
            </a:r>
          </a:p>
          <a:p>
            <a:r>
              <a:rPr lang="en-US" altLang="zh-CN" dirty="0"/>
              <a:t>105KD</a:t>
            </a:r>
            <a:endParaRPr lang="zh-CN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A8C5784A-E751-4713-B929-B408C372C1F3}"/>
              </a:ext>
            </a:extLst>
          </p:cNvPr>
          <p:cNvSpPr txBox="1"/>
          <p:nvPr/>
        </p:nvSpPr>
        <p:spPr>
          <a:xfrm>
            <a:off x="1745356" y="5051483"/>
            <a:ext cx="1285929" cy="8617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3200" b="1" dirty="0"/>
              <a:t>Fig.5E</a:t>
            </a:r>
          </a:p>
          <a:p>
            <a:endParaRPr lang="zh-CN" altLang="en-US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A8B3489A-C3FF-43EE-AC3F-1E318B95BD6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327" y="802166"/>
            <a:ext cx="4642728" cy="1539387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D61BCCA3-4353-4A57-8362-D22E7A6FA9D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326" y="2762036"/>
            <a:ext cx="4588175" cy="1419546"/>
          </a:xfrm>
          <a:prstGeom prst="rect">
            <a:avLst/>
          </a:prstGeom>
        </p:spPr>
      </p:pic>
      <p:sp>
        <p:nvSpPr>
          <p:cNvPr id="9" name="矩形 8">
            <a:extLst>
              <a:ext uri="{FF2B5EF4-FFF2-40B4-BE49-F238E27FC236}">
                <a16:creationId xmlns:a16="http://schemas.microsoft.com/office/drawing/2014/main" id="{F96312C6-7912-4EDA-8095-33FE297AE8E8}"/>
              </a:ext>
            </a:extLst>
          </p:cNvPr>
          <p:cNvSpPr/>
          <p:nvPr/>
        </p:nvSpPr>
        <p:spPr>
          <a:xfrm>
            <a:off x="419987" y="1525369"/>
            <a:ext cx="2857467" cy="36676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FE405157-40F2-4D04-977D-0A82C16C6959}"/>
              </a:ext>
            </a:extLst>
          </p:cNvPr>
          <p:cNvSpPr/>
          <p:nvPr/>
        </p:nvSpPr>
        <p:spPr>
          <a:xfrm>
            <a:off x="316622" y="3409697"/>
            <a:ext cx="2857467" cy="36676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779120BF-765A-4712-B4C3-C1C4CCFEEF5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309003" y="1"/>
            <a:ext cx="3657662" cy="2762036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49A7CF48-A4EA-42C1-953C-34201B46080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326587" y="2820270"/>
            <a:ext cx="3640077" cy="2535502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A0AA2370-8683-43A4-A218-3FF2C66AF902}"/>
              </a:ext>
            </a:extLst>
          </p:cNvPr>
          <p:cNvSpPr txBox="1"/>
          <p:nvPr/>
        </p:nvSpPr>
        <p:spPr>
          <a:xfrm>
            <a:off x="7396574" y="340501"/>
            <a:ext cx="91242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stat3</a:t>
            </a:r>
          </a:p>
          <a:p>
            <a:r>
              <a:rPr lang="en-US" altLang="zh-CN" dirty="0"/>
              <a:t>105KD</a:t>
            </a:r>
          </a:p>
          <a:p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9C147138-F4BA-463D-B66A-317FB79816F3}"/>
              </a:ext>
            </a:extLst>
          </p:cNvPr>
          <p:cNvSpPr txBox="1"/>
          <p:nvPr/>
        </p:nvSpPr>
        <p:spPr>
          <a:xfrm>
            <a:off x="7489498" y="3048810"/>
            <a:ext cx="83708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tat3</a:t>
            </a:r>
          </a:p>
          <a:p>
            <a:r>
              <a:rPr lang="en-US" altLang="zh-CN" dirty="0"/>
              <a:t>105KD</a:t>
            </a:r>
            <a:endParaRPr lang="zh-CN" altLang="en-US" dirty="0"/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C9C6C855-EF46-4555-8D59-24478166DE80}"/>
              </a:ext>
            </a:extLst>
          </p:cNvPr>
          <p:cNvSpPr/>
          <p:nvPr/>
        </p:nvSpPr>
        <p:spPr>
          <a:xfrm>
            <a:off x="9163594" y="450670"/>
            <a:ext cx="1045029" cy="19594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23252AA3-5601-483C-94D6-58735E853388}"/>
              </a:ext>
            </a:extLst>
          </p:cNvPr>
          <p:cNvSpPr/>
          <p:nvPr/>
        </p:nvSpPr>
        <p:spPr>
          <a:xfrm>
            <a:off x="9342462" y="3275868"/>
            <a:ext cx="1045029" cy="19594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62495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54E56255-C2F6-4457-A718-5157C08BC346}"/>
              </a:ext>
            </a:extLst>
          </p:cNvPr>
          <p:cNvSpPr txBox="1"/>
          <p:nvPr/>
        </p:nvSpPr>
        <p:spPr>
          <a:xfrm>
            <a:off x="6248937" y="4181516"/>
            <a:ext cx="906017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stat3</a:t>
            </a:r>
          </a:p>
          <a:p>
            <a:r>
              <a:rPr lang="en-US" altLang="zh-CN" dirty="0"/>
              <a:t>105KD</a:t>
            </a:r>
          </a:p>
          <a:p>
            <a:r>
              <a:rPr lang="en-US" altLang="zh-CN" dirty="0"/>
              <a:t> </a:t>
            </a:r>
            <a:endParaRPr lang="zh-CN" altLang="en-US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4C487548-E12E-47BC-86A6-B1CBD19F3B80}"/>
              </a:ext>
            </a:extLst>
          </p:cNvPr>
          <p:cNvSpPr txBox="1"/>
          <p:nvPr/>
        </p:nvSpPr>
        <p:spPr>
          <a:xfrm>
            <a:off x="6317292" y="3005574"/>
            <a:ext cx="84830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/>
              <a:t>Gapdh</a:t>
            </a:r>
            <a:endParaRPr lang="en-US" altLang="zh-CN" dirty="0"/>
          </a:p>
          <a:p>
            <a:r>
              <a:rPr lang="en-US" altLang="zh-CN" dirty="0"/>
              <a:t>36KD</a:t>
            </a:r>
            <a:endParaRPr lang="zh-CN" altLang="en-US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C04A1F64-D377-4E68-A36A-1A6A31DD04B5}"/>
              </a:ext>
            </a:extLst>
          </p:cNvPr>
          <p:cNvSpPr txBox="1"/>
          <p:nvPr/>
        </p:nvSpPr>
        <p:spPr>
          <a:xfrm>
            <a:off x="6311658" y="1008401"/>
            <a:ext cx="715260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IL-6</a:t>
            </a:r>
          </a:p>
          <a:p>
            <a:r>
              <a:rPr lang="en-US" altLang="zh-CN" dirty="0"/>
              <a:t>28KD</a:t>
            </a:r>
          </a:p>
          <a:p>
            <a:endParaRPr lang="zh-CN" altLang="en-US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EF219820-A3ED-403C-94D3-6CB41C2F21B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9282" y="611596"/>
            <a:ext cx="4986338" cy="1560103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F9113BD5-8450-4E0C-9457-9E8F6DC6628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3106" y="2398585"/>
            <a:ext cx="4862514" cy="1333500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288DD451-13F8-4908-A562-6673361E856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6443" y="4105019"/>
            <a:ext cx="5181600" cy="1076325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68ED13A3-496A-4602-9CA1-1EBFE878F73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4056" y="5551078"/>
            <a:ext cx="5410200" cy="695325"/>
          </a:xfrm>
          <a:prstGeom prst="rect">
            <a:avLst/>
          </a:prstGeom>
        </p:spPr>
      </p:pic>
      <p:sp>
        <p:nvSpPr>
          <p:cNvPr id="24" name="文本框 23">
            <a:extLst>
              <a:ext uri="{FF2B5EF4-FFF2-40B4-BE49-F238E27FC236}">
                <a16:creationId xmlns:a16="http://schemas.microsoft.com/office/drawing/2014/main" id="{B7338986-E59A-4588-A5CA-A156198AB3FE}"/>
              </a:ext>
            </a:extLst>
          </p:cNvPr>
          <p:cNvSpPr txBox="1"/>
          <p:nvPr/>
        </p:nvSpPr>
        <p:spPr>
          <a:xfrm>
            <a:off x="6355390" y="5639917"/>
            <a:ext cx="84830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/>
              <a:t>Gapdh</a:t>
            </a:r>
            <a:endParaRPr lang="en-US" altLang="zh-CN" dirty="0"/>
          </a:p>
          <a:p>
            <a:r>
              <a:rPr lang="en-US" altLang="zh-CN" dirty="0"/>
              <a:t>36KD</a:t>
            </a:r>
            <a:endParaRPr lang="zh-CN" altLang="en-US" dirty="0"/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91313B8A-7F95-46B4-85D9-528BE7ADFB40}"/>
              </a:ext>
            </a:extLst>
          </p:cNvPr>
          <p:cNvSpPr/>
          <p:nvPr/>
        </p:nvSpPr>
        <p:spPr>
          <a:xfrm>
            <a:off x="2225040" y="1249680"/>
            <a:ext cx="1381760" cy="2336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E51A77E2-EDB9-4957-8DBA-258F48F2A7CA}"/>
              </a:ext>
            </a:extLst>
          </p:cNvPr>
          <p:cNvSpPr/>
          <p:nvPr/>
        </p:nvSpPr>
        <p:spPr>
          <a:xfrm>
            <a:off x="2225040" y="3299840"/>
            <a:ext cx="1381760" cy="2336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矩形 25">
            <a:extLst>
              <a:ext uri="{FF2B5EF4-FFF2-40B4-BE49-F238E27FC236}">
                <a16:creationId xmlns:a16="http://schemas.microsoft.com/office/drawing/2014/main" id="{1F111B72-6B63-4A68-B971-E63550C10898}"/>
              </a:ext>
            </a:extLst>
          </p:cNvPr>
          <p:cNvSpPr/>
          <p:nvPr/>
        </p:nvSpPr>
        <p:spPr>
          <a:xfrm>
            <a:off x="985520" y="4317934"/>
            <a:ext cx="1838960" cy="3154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89AB5162-EFC6-46E9-8423-30B135BC0FC0}"/>
              </a:ext>
            </a:extLst>
          </p:cNvPr>
          <p:cNvSpPr/>
          <p:nvPr/>
        </p:nvSpPr>
        <p:spPr>
          <a:xfrm>
            <a:off x="945402" y="5805379"/>
            <a:ext cx="2031477" cy="27030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" name="右大括号 1">
            <a:extLst>
              <a:ext uri="{FF2B5EF4-FFF2-40B4-BE49-F238E27FC236}">
                <a16:creationId xmlns:a16="http://schemas.microsoft.com/office/drawing/2014/main" id="{D70155D8-E558-4605-B93C-0FFB8FB395C5}"/>
              </a:ext>
            </a:extLst>
          </p:cNvPr>
          <p:cNvSpPr/>
          <p:nvPr/>
        </p:nvSpPr>
        <p:spPr>
          <a:xfrm>
            <a:off x="7438490" y="1089061"/>
            <a:ext cx="472611" cy="2339939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E9382566-7C46-49A4-8E5E-BA6A34346773}"/>
              </a:ext>
            </a:extLst>
          </p:cNvPr>
          <p:cNvSpPr txBox="1"/>
          <p:nvPr/>
        </p:nvSpPr>
        <p:spPr>
          <a:xfrm>
            <a:off x="8835775" y="1868897"/>
            <a:ext cx="8402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.7A</a:t>
            </a:r>
            <a:endParaRPr lang="zh-CN" altLang="en-US" b="1" dirty="0"/>
          </a:p>
        </p:txBody>
      </p:sp>
      <p:sp>
        <p:nvSpPr>
          <p:cNvPr id="16" name="右大括号 15">
            <a:extLst>
              <a:ext uri="{FF2B5EF4-FFF2-40B4-BE49-F238E27FC236}">
                <a16:creationId xmlns:a16="http://schemas.microsoft.com/office/drawing/2014/main" id="{EFDD6E38-DA7A-4BF9-8345-E767F1AF1D4F}"/>
              </a:ext>
            </a:extLst>
          </p:cNvPr>
          <p:cNvSpPr/>
          <p:nvPr/>
        </p:nvSpPr>
        <p:spPr>
          <a:xfrm>
            <a:off x="7529782" y="4014485"/>
            <a:ext cx="472611" cy="2339939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6CD572B3-3FBF-44A1-8CAE-C681FA4D92C4}"/>
              </a:ext>
            </a:extLst>
          </p:cNvPr>
          <p:cNvSpPr txBox="1"/>
          <p:nvPr/>
        </p:nvSpPr>
        <p:spPr>
          <a:xfrm>
            <a:off x="8835774" y="4920180"/>
            <a:ext cx="8242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.7B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257468774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54E56255-C2F6-4457-A718-5157C08BC346}"/>
              </a:ext>
            </a:extLst>
          </p:cNvPr>
          <p:cNvSpPr txBox="1"/>
          <p:nvPr/>
        </p:nvSpPr>
        <p:spPr>
          <a:xfrm>
            <a:off x="4247022" y="4091085"/>
            <a:ext cx="715260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ctin</a:t>
            </a:r>
          </a:p>
          <a:p>
            <a:r>
              <a:rPr lang="en-US" altLang="zh-CN" dirty="0"/>
              <a:t>42KD</a:t>
            </a:r>
          </a:p>
          <a:p>
            <a:r>
              <a:rPr lang="en-US" altLang="zh-CN" dirty="0"/>
              <a:t> </a:t>
            </a:r>
            <a:endParaRPr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608E8EDD-9708-4DEA-9269-905303AE4CF2}"/>
              </a:ext>
            </a:extLst>
          </p:cNvPr>
          <p:cNvSpPr txBox="1"/>
          <p:nvPr/>
        </p:nvSpPr>
        <p:spPr>
          <a:xfrm>
            <a:off x="7266446" y="1403449"/>
            <a:ext cx="710451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IL-1β</a:t>
            </a:r>
          </a:p>
          <a:p>
            <a:r>
              <a:rPr lang="en-US" altLang="zh-CN" dirty="0"/>
              <a:t>37KD</a:t>
            </a:r>
          </a:p>
          <a:p>
            <a:endParaRPr lang="zh-CN" altLang="en-US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4C487548-E12E-47BC-86A6-B1CBD19F3B80}"/>
              </a:ext>
            </a:extLst>
          </p:cNvPr>
          <p:cNvSpPr txBox="1"/>
          <p:nvPr/>
        </p:nvSpPr>
        <p:spPr>
          <a:xfrm>
            <a:off x="7162250" y="4229584"/>
            <a:ext cx="81464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TNF-a</a:t>
            </a:r>
          </a:p>
          <a:p>
            <a:r>
              <a:rPr lang="en-US" altLang="zh-CN" dirty="0"/>
              <a:t>27KD</a:t>
            </a:r>
            <a:endParaRPr lang="zh-CN" altLang="en-US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C04A1F64-D377-4E68-A36A-1A6A31DD04B5}"/>
              </a:ext>
            </a:extLst>
          </p:cNvPr>
          <p:cNvSpPr txBox="1"/>
          <p:nvPr/>
        </p:nvSpPr>
        <p:spPr>
          <a:xfrm>
            <a:off x="4415701" y="1933324"/>
            <a:ext cx="708848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IL-18</a:t>
            </a:r>
          </a:p>
          <a:p>
            <a:r>
              <a:rPr lang="en-US" altLang="zh-CN" dirty="0"/>
              <a:t>23KD</a:t>
            </a:r>
          </a:p>
          <a:p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1454F185-8693-4494-AE6B-4113245E83FB}"/>
              </a:ext>
            </a:extLst>
          </p:cNvPr>
          <p:cNvSpPr txBox="1"/>
          <p:nvPr/>
        </p:nvSpPr>
        <p:spPr>
          <a:xfrm>
            <a:off x="4378222" y="5788658"/>
            <a:ext cx="3435556" cy="8617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3200" b="1" dirty="0"/>
              <a:t>Supplement Fig.1</a:t>
            </a:r>
          </a:p>
          <a:p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6CCDB2B6-46F3-45FD-B68F-D4D1A0D8F96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9288" y="3186744"/>
            <a:ext cx="3893401" cy="2794171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4D3C75E6-61FA-47F0-A385-C45DFED3C4C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976897" y="387538"/>
            <a:ext cx="3613563" cy="2323005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A7D5D683-9866-4892-B290-01C68434443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9288" y="404439"/>
            <a:ext cx="3857734" cy="2562226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C0F05960-FF4F-42C9-BCFD-C82B0BEC895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984354" y="2809972"/>
            <a:ext cx="3818358" cy="2562225"/>
          </a:xfrm>
          <a:prstGeom prst="rect">
            <a:avLst/>
          </a:prstGeom>
        </p:spPr>
      </p:pic>
      <p:sp>
        <p:nvSpPr>
          <p:cNvPr id="15" name="矩形 14">
            <a:extLst>
              <a:ext uri="{FF2B5EF4-FFF2-40B4-BE49-F238E27FC236}">
                <a16:creationId xmlns:a16="http://schemas.microsoft.com/office/drawing/2014/main" id="{04DA0E89-C052-4579-AAB2-7002356E5714}"/>
              </a:ext>
            </a:extLst>
          </p:cNvPr>
          <p:cNvSpPr/>
          <p:nvPr/>
        </p:nvSpPr>
        <p:spPr>
          <a:xfrm>
            <a:off x="2492932" y="2010705"/>
            <a:ext cx="1295297" cy="24263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540AEEE0-D847-41FA-980D-A907AA87E4B7}"/>
              </a:ext>
            </a:extLst>
          </p:cNvPr>
          <p:cNvSpPr/>
          <p:nvPr/>
        </p:nvSpPr>
        <p:spPr>
          <a:xfrm>
            <a:off x="2544401" y="4310111"/>
            <a:ext cx="1295297" cy="24263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1F86600E-5E8A-42AB-9160-FB01AEA541F6}"/>
              </a:ext>
            </a:extLst>
          </p:cNvPr>
          <p:cNvSpPr/>
          <p:nvPr/>
        </p:nvSpPr>
        <p:spPr>
          <a:xfrm>
            <a:off x="10064252" y="4343400"/>
            <a:ext cx="1295297" cy="24446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B5BB76BB-CE56-466C-B42B-8BD2C64C2346}"/>
              </a:ext>
            </a:extLst>
          </p:cNvPr>
          <p:cNvSpPr/>
          <p:nvPr/>
        </p:nvSpPr>
        <p:spPr>
          <a:xfrm>
            <a:off x="9893533" y="1563321"/>
            <a:ext cx="1295297" cy="24446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623315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54E56255-C2F6-4457-A718-5157C08BC346}"/>
              </a:ext>
            </a:extLst>
          </p:cNvPr>
          <p:cNvSpPr txBox="1"/>
          <p:nvPr/>
        </p:nvSpPr>
        <p:spPr>
          <a:xfrm>
            <a:off x="11208666" y="2163252"/>
            <a:ext cx="84830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/>
              <a:t>Gapdh</a:t>
            </a:r>
            <a:endParaRPr lang="en-US" altLang="zh-CN" dirty="0"/>
          </a:p>
          <a:p>
            <a:r>
              <a:rPr lang="en-US" altLang="zh-CN" dirty="0"/>
              <a:t>36KD</a:t>
            </a:r>
          </a:p>
          <a:p>
            <a:r>
              <a:rPr lang="en-US" altLang="zh-CN" dirty="0"/>
              <a:t> </a:t>
            </a:r>
            <a:endParaRPr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608E8EDD-9708-4DEA-9269-905303AE4CF2}"/>
              </a:ext>
            </a:extLst>
          </p:cNvPr>
          <p:cNvSpPr txBox="1"/>
          <p:nvPr/>
        </p:nvSpPr>
        <p:spPr>
          <a:xfrm>
            <a:off x="10908995" y="439521"/>
            <a:ext cx="1283006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HIF-2a</a:t>
            </a:r>
          </a:p>
          <a:p>
            <a:r>
              <a:rPr lang="en-US" altLang="zh-CN" dirty="0"/>
              <a:t>120KD</a:t>
            </a:r>
          </a:p>
          <a:p>
            <a:r>
              <a:rPr lang="en-US" altLang="zh-CN" u="sng" dirty="0"/>
              <a:t>Observed at 140KD</a:t>
            </a:r>
          </a:p>
          <a:p>
            <a:endParaRPr lang="zh-CN" altLang="en-US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C04A1F64-D377-4E68-A36A-1A6A31DD04B5}"/>
              </a:ext>
            </a:extLst>
          </p:cNvPr>
          <p:cNvSpPr txBox="1"/>
          <p:nvPr/>
        </p:nvSpPr>
        <p:spPr>
          <a:xfrm>
            <a:off x="4337667" y="1396832"/>
            <a:ext cx="83708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HIF1a</a:t>
            </a:r>
          </a:p>
          <a:p>
            <a:r>
              <a:rPr lang="en-US" altLang="zh-CN" dirty="0"/>
              <a:t>100KD</a:t>
            </a:r>
          </a:p>
          <a:p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1454F185-8693-4494-AE6B-4113245E83FB}"/>
              </a:ext>
            </a:extLst>
          </p:cNvPr>
          <p:cNvSpPr txBox="1"/>
          <p:nvPr/>
        </p:nvSpPr>
        <p:spPr>
          <a:xfrm>
            <a:off x="4378222" y="5788658"/>
            <a:ext cx="3435556" cy="8617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3200" b="1" dirty="0"/>
              <a:t>Supplement Fig.2</a:t>
            </a:r>
          </a:p>
          <a:p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BDAED5CB-D078-4109-A979-A4141CF48A88}"/>
              </a:ext>
            </a:extLst>
          </p:cNvPr>
          <p:cNvSpPr txBox="1"/>
          <p:nvPr/>
        </p:nvSpPr>
        <p:spPr>
          <a:xfrm>
            <a:off x="4378222" y="4730573"/>
            <a:ext cx="84830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/>
              <a:t>Gapdh</a:t>
            </a:r>
            <a:endParaRPr lang="en-US" altLang="zh-CN" dirty="0"/>
          </a:p>
          <a:p>
            <a:r>
              <a:rPr lang="en-US" altLang="zh-CN" dirty="0"/>
              <a:t>36KD</a:t>
            </a:r>
          </a:p>
          <a:p>
            <a:r>
              <a:rPr lang="en-US" altLang="zh-CN" dirty="0"/>
              <a:t> </a:t>
            </a:r>
            <a:endParaRPr lang="zh-CN" altLang="en-US" dirty="0"/>
          </a:p>
        </p:txBody>
      </p:sp>
      <p:pic>
        <p:nvPicPr>
          <p:cNvPr id="25" name="图片 24">
            <a:extLst>
              <a:ext uri="{FF2B5EF4-FFF2-40B4-BE49-F238E27FC236}">
                <a16:creationId xmlns:a16="http://schemas.microsoft.com/office/drawing/2014/main" id="{06C8E12E-F6DE-499B-93ED-5A078496481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546" y="129661"/>
            <a:ext cx="4325040" cy="3057231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6BE599D1-861C-43D5-8F55-FF5C4EC955D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182" y="3125660"/>
            <a:ext cx="4279768" cy="3209826"/>
          </a:xfrm>
          <a:prstGeom prst="rect">
            <a:avLst/>
          </a:prstGeom>
        </p:spPr>
      </p:pic>
      <p:sp>
        <p:nvSpPr>
          <p:cNvPr id="29" name="矩形 28">
            <a:extLst>
              <a:ext uri="{FF2B5EF4-FFF2-40B4-BE49-F238E27FC236}">
                <a16:creationId xmlns:a16="http://schemas.microsoft.com/office/drawing/2014/main" id="{4B1E9FD2-2606-45AF-B8B6-91D5B9E29D07}"/>
              </a:ext>
            </a:extLst>
          </p:cNvPr>
          <p:cNvSpPr/>
          <p:nvPr/>
        </p:nvSpPr>
        <p:spPr>
          <a:xfrm>
            <a:off x="2147299" y="1559673"/>
            <a:ext cx="1324425" cy="19720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2" name="矩形 31">
            <a:extLst>
              <a:ext uri="{FF2B5EF4-FFF2-40B4-BE49-F238E27FC236}">
                <a16:creationId xmlns:a16="http://schemas.microsoft.com/office/drawing/2014/main" id="{BF9102BC-3179-4763-A7C8-AB33A153A3A2}"/>
              </a:ext>
            </a:extLst>
          </p:cNvPr>
          <p:cNvSpPr/>
          <p:nvPr/>
        </p:nvSpPr>
        <p:spPr>
          <a:xfrm>
            <a:off x="1878458" y="4995029"/>
            <a:ext cx="1593266" cy="30329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33" name="图片 32">
            <a:extLst>
              <a:ext uri="{FF2B5EF4-FFF2-40B4-BE49-F238E27FC236}">
                <a16:creationId xmlns:a16="http://schemas.microsoft.com/office/drawing/2014/main" id="{4B9EC06B-E4F8-4983-AD9B-48EC9274AD4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394019" y="213831"/>
            <a:ext cx="5514975" cy="1543050"/>
          </a:xfrm>
          <a:prstGeom prst="rect">
            <a:avLst/>
          </a:prstGeom>
        </p:spPr>
      </p:pic>
      <p:sp>
        <p:nvSpPr>
          <p:cNvPr id="36" name="矩形 35">
            <a:extLst>
              <a:ext uri="{FF2B5EF4-FFF2-40B4-BE49-F238E27FC236}">
                <a16:creationId xmlns:a16="http://schemas.microsoft.com/office/drawing/2014/main" id="{76960108-1A9F-45D5-B713-46FD6DFDB1B8}"/>
              </a:ext>
            </a:extLst>
          </p:cNvPr>
          <p:cNvSpPr/>
          <p:nvPr/>
        </p:nvSpPr>
        <p:spPr>
          <a:xfrm>
            <a:off x="8273512" y="496288"/>
            <a:ext cx="1531428" cy="4828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37" name="图片 36">
            <a:extLst>
              <a:ext uri="{FF2B5EF4-FFF2-40B4-BE49-F238E27FC236}">
                <a16:creationId xmlns:a16="http://schemas.microsoft.com/office/drawing/2014/main" id="{FDEBA9C5-819C-4CBB-931A-E6EABCE5A95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325525" y="2001710"/>
            <a:ext cx="5895975" cy="1123950"/>
          </a:xfrm>
          <a:prstGeom prst="rect">
            <a:avLst/>
          </a:prstGeom>
        </p:spPr>
      </p:pic>
      <p:sp>
        <p:nvSpPr>
          <p:cNvPr id="38" name="矩形 37">
            <a:extLst>
              <a:ext uri="{FF2B5EF4-FFF2-40B4-BE49-F238E27FC236}">
                <a16:creationId xmlns:a16="http://schemas.microsoft.com/office/drawing/2014/main" id="{EC8748B4-1847-4FF5-BF67-4A9232DC104F}"/>
              </a:ext>
            </a:extLst>
          </p:cNvPr>
          <p:cNvSpPr/>
          <p:nvPr/>
        </p:nvSpPr>
        <p:spPr>
          <a:xfrm>
            <a:off x="8558737" y="2431390"/>
            <a:ext cx="1716363" cy="38705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2118512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文本框 29">
            <a:extLst>
              <a:ext uri="{FF2B5EF4-FFF2-40B4-BE49-F238E27FC236}">
                <a16:creationId xmlns:a16="http://schemas.microsoft.com/office/drawing/2014/main" id="{4C487548-E12E-47BC-86A6-B1CBD19F3B80}"/>
              </a:ext>
            </a:extLst>
          </p:cNvPr>
          <p:cNvSpPr txBox="1"/>
          <p:nvPr/>
        </p:nvSpPr>
        <p:spPr>
          <a:xfrm>
            <a:off x="481560" y="1844810"/>
            <a:ext cx="84510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/>
              <a:t>VEGFa</a:t>
            </a:r>
            <a:endParaRPr lang="en-US" altLang="zh-CN" dirty="0"/>
          </a:p>
          <a:p>
            <a:r>
              <a:rPr lang="en-US" altLang="zh-CN" dirty="0"/>
              <a:t>27KD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1454F185-8693-4494-AE6B-4113245E83FB}"/>
              </a:ext>
            </a:extLst>
          </p:cNvPr>
          <p:cNvSpPr txBox="1"/>
          <p:nvPr/>
        </p:nvSpPr>
        <p:spPr>
          <a:xfrm>
            <a:off x="7187521" y="5039525"/>
            <a:ext cx="3435556" cy="8617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3200" b="1" dirty="0"/>
              <a:t>Supplement Fig.2</a:t>
            </a:r>
          </a:p>
          <a:p>
            <a:endParaRPr lang="zh-CN" altLang="en-US" dirty="0"/>
          </a:p>
        </p:txBody>
      </p:sp>
      <p:pic>
        <p:nvPicPr>
          <p:cNvPr id="21" name="图片 20">
            <a:extLst>
              <a:ext uri="{FF2B5EF4-FFF2-40B4-BE49-F238E27FC236}">
                <a16:creationId xmlns:a16="http://schemas.microsoft.com/office/drawing/2014/main" id="{7BABB84D-910A-4757-9C3C-E94025F8DF8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17778" y="3229582"/>
            <a:ext cx="4183685" cy="3135932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F88DCF47-EC9E-4B6B-B982-B8389BA2A4B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12725" y="207568"/>
            <a:ext cx="4883275" cy="2919809"/>
          </a:xfrm>
          <a:prstGeom prst="rect">
            <a:avLst/>
          </a:prstGeom>
        </p:spPr>
      </p:pic>
      <p:sp>
        <p:nvSpPr>
          <p:cNvPr id="26" name="文本框 25">
            <a:extLst>
              <a:ext uri="{FF2B5EF4-FFF2-40B4-BE49-F238E27FC236}">
                <a16:creationId xmlns:a16="http://schemas.microsoft.com/office/drawing/2014/main" id="{D1CF3BD0-489E-4690-8BA5-DB8AFC7328F9}"/>
              </a:ext>
            </a:extLst>
          </p:cNvPr>
          <p:cNvSpPr txBox="1"/>
          <p:nvPr/>
        </p:nvSpPr>
        <p:spPr>
          <a:xfrm>
            <a:off x="694715" y="5008747"/>
            <a:ext cx="84830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/>
              <a:t>Gapdh</a:t>
            </a:r>
            <a:endParaRPr lang="en-US" altLang="zh-CN" dirty="0"/>
          </a:p>
          <a:p>
            <a:r>
              <a:rPr lang="en-US" altLang="zh-CN" dirty="0"/>
              <a:t>36KD</a:t>
            </a:r>
          </a:p>
          <a:p>
            <a:r>
              <a:rPr lang="en-US" altLang="zh-CN" dirty="0"/>
              <a:t> </a:t>
            </a:r>
            <a:endParaRPr lang="zh-CN" altLang="en-US" dirty="0"/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39715A28-5142-4BC6-977F-1455C0E8A4C0}"/>
              </a:ext>
            </a:extLst>
          </p:cNvPr>
          <p:cNvSpPr/>
          <p:nvPr/>
        </p:nvSpPr>
        <p:spPr>
          <a:xfrm>
            <a:off x="1717778" y="2004986"/>
            <a:ext cx="1587076" cy="24467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5045DA99-68FF-4059-A9F7-7504EFAC3828}"/>
              </a:ext>
            </a:extLst>
          </p:cNvPr>
          <p:cNvSpPr/>
          <p:nvPr/>
        </p:nvSpPr>
        <p:spPr>
          <a:xfrm>
            <a:off x="2067286" y="5053642"/>
            <a:ext cx="1587076" cy="24467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565021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747DEB39-4D69-4B02-9087-89AA9F9B6AD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99003" y="2754391"/>
            <a:ext cx="4181475" cy="1104900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1D2BB6E2-3E63-4A18-BD9A-EFE4CA7D169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28149" y="1300136"/>
            <a:ext cx="4781550" cy="1409700"/>
          </a:xfrm>
          <a:prstGeom prst="rect">
            <a:avLst/>
          </a:prstGeom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1454F185-8693-4494-AE6B-4113245E83FB}"/>
              </a:ext>
            </a:extLst>
          </p:cNvPr>
          <p:cNvSpPr txBox="1"/>
          <p:nvPr/>
        </p:nvSpPr>
        <p:spPr>
          <a:xfrm>
            <a:off x="7187521" y="5039525"/>
            <a:ext cx="3435556" cy="8617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3200" b="1" dirty="0"/>
              <a:t>Supplement Fig.3</a:t>
            </a:r>
          </a:p>
          <a:p>
            <a:endParaRPr lang="zh-CN" altLang="en-US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D1CF3BD0-489E-4690-8BA5-DB8AFC7328F9}"/>
              </a:ext>
            </a:extLst>
          </p:cNvPr>
          <p:cNvSpPr txBox="1"/>
          <p:nvPr/>
        </p:nvSpPr>
        <p:spPr>
          <a:xfrm>
            <a:off x="750694" y="2967335"/>
            <a:ext cx="84830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/>
              <a:t>Gapdh</a:t>
            </a:r>
            <a:endParaRPr lang="en-US" altLang="zh-CN" dirty="0"/>
          </a:p>
          <a:p>
            <a:r>
              <a:rPr lang="en-US" altLang="zh-CN" dirty="0"/>
              <a:t>36KD</a:t>
            </a:r>
          </a:p>
          <a:p>
            <a:r>
              <a:rPr lang="en-US" altLang="zh-CN" dirty="0"/>
              <a:t> </a:t>
            </a:r>
            <a:endParaRPr lang="zh-CN" altLang="en-US" dirty="0"/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39715A28-5142-4BC6-977F-1455C0E8A4C0}"/>
              </a:ext>
            </a:extLst>
          </p:cNvPr>
          <p:cNvSpPr/>
          <p:nvPr/>
        </p:nvSpPr>
        <p:spPr>
          <a:xfrm>
            <a:off x="1717778" y="2004986"/>
            <a:ext cx="1302824" cy="28615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5045DA99-68FF-4059-A9F7-7504EFAC3828}"/>
              </a:ext>
            </a:extLst>
          </p:cNvPr>
          <p:cNvSpPr/>
          <p:nvPr/>
        </p:nvSpPr>
        <p:spPr>
          <a:xfrm>
            <a:off x="1656508" y="2995987"/>
            <a:ext cx="1281901" cy="27119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29E3036E-9664-4529-8828-00F348C54A14}"/>
              </a:ext>
            </a:extLst>
          </p:cNvPr>
          <p:cNvSpPr txBox="1"/>
          <p:nvPr/>
        </p:nvSpPr>
        <p:spPr>
          <a:xfrm>
            <a:off x="270272" y="1789854"/>
            <a:ext cx="2109873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HIF-2a</a:t>
            </a:r>
          </a:p>
          <a:p>
            <a:r>
              <a:rPr lang="en-US" altLang="zh-CN" dirty="0"/>
              <a:t>120KD</a:t>
            </a:r>
          </a:p>
          <a:p>
            <a:r>
              <a:rPr lang="en-US" altLang="zh-CN" u="sng" dirty="0"/>
              <a:t>Observed at 140KD</a:t>
            </a:r>
          </a:p>
          <a:p>
            <a:endParaRPr lang="en-US" altLang="zh-CN" dirty="0"/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783555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1</TotalTime>
  <Words>91</Words>
  <Application>Microsoft Office PowerPoint</Application>
  <PresentationFormat>宽屏</PresentationFormat>
  <Paragraphs>65</Paragraphs>
  <Slides>8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2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ang Mengting</dc:creator>
  <cp:lastModifiedBy>Zhang Mengting</cp:lastModifiedBy>
  <cp:revision>18</cp:revision>
  <dcterms:created xsi:type="dcterms:W3CDTF">2021-06-20T16:07:34Z</dcterms:created>
  <dcterms:modified xsi:type="dcterms:W3CDTF">2022-03-08T05:29:09Z</dcterms:modified>
</cp:coreProperties>
</file>